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-456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26628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978059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1416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767468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882053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87938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75842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93089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858632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614142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707184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990053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nl-NL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134" b="6467"/>
          <a:stretch/>
        </p:blipFill>
        <p:spPr>
          <a:xfrm>
            <a:off x="251519" y="1617304"/>
            <a:ext cx="8499631" cy="5124063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0" y="208839"/>
            <a:ext cx="914400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Additional file 4: Viable counts during spoilage of RTE rice meals in absence/presence of food preservatives.</a:t>
            </a:r>
            <a:r>
              <a:rPr lang="en-US" sz="1200" dirty="0"/>
              <a:t> Colony Forming Unit (CFU) counts of the various RTE meal samples during 12 days storage/spoilage at 7 °C. The upper and lower panel show CFU counts on TSA and MRSA plates, respectively. The 5 different sample treatments are indicated from left to right: untreated (only pH adjusted), </a:t>
            </a:r>
            <a:r>
              <a:rPr lang="en-US" sz="1200" dirty="0" err="1"/>
              <a:t>sorbate</a:t>
            </a:r>
            <a:r>
              <a:rPr lang="en-US" sz="1200" dirty="0"/>
              <a:t>, propionate, lactate, and acetate respectively. Note that each CFU count (each bar) is derived from a unique sample. This explains why there are differences between samples taken at the same time (</a:t>
            </a:r>
            <a:r>
              <a:rPr lang="en-US" sz="1200" i="1" dirty="0"/>
              <a:t>e.g.</a:t>
            </a:r>
            <a:r>
              <a:rPr lang="en-US" sz="1200" dirty="0"/>
              <a:t> B, t08 where one untreated and one </a:t>
            </a:r>
            <a:r>
              <a:rPr lang="en-US" sz="1200" dirty="0" err="1"/>
              <a:t>sorbate</a:t>
            </a:r>
            <a:r>
              <a:rPr lang="en-US" sz="1200" dirty="0"/>
              <a:t>-treated sample showed clear growth, but the other untreated and </a:t>
            </a:r>
            <a:r>
              <a:rPr lang="en-US" sz="1200" dirty="0" err="1"/>
              <a:t>sorbate</a:t>
            </a:r>
            <a:r>
              <a:rPr lang="en-US" sz="1200" dirty="0"/>
              <a:t>-treated sample did not show growth). The dashed black lines depict the detection limit: bars below this dashed line represent samples where no growth was observed. </a:t>
            </a:r>
            <a:endParaRPr lang="nl-NL" sz="1200" dirty="0"/>
          </a:p>
        </p:txBody>
      </p:sp>
    </p:spTree>
    <p:extLst>
      <p:ext uri="{BB962C8B-B14F-4D97-AF65-F5344CB8AC3E}">
        <p14:creationId xmlns:p14="http://schemas.microsoft.com/office/powerpoint/2010/main" val="2002273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64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admin</cp:lastModifiedBy>
  <cp:revision>2</cp:revision>
  <dcterms:created xsi:type="dcterms:W3CDTF">2015-05-01T20:53:39Z</dcterms:created>
  <dcterms:modified xsi:type="dcterms:W3CDTF">2015-05-01T20:58:49Z</dcterms:modified>
</cp:coreProperties>
</file>